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96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xandra Le Bras" userId="5153c689-b14b-471b-9cb0-9e9db3b9e899" providerId="ADAL" clId="{46E1D936-2C78-4791-9B2B-5869E6F894A0}"/>
    <pc:docChg chg="delSld">
      <pc:chgData name="Alexandra Le Bras" userId="5153c689-b14b-471b-9cb0-9e9db3b9e899" providerId="ADAL" clId="{46E1D936-2C78-4791-9B2B-5869E6F894A0}" dt="2025-07-11T11:08:36.273" v="1" actId="47"/>
      <pc:docMkLst>
        <pc:docMk/>
      </pc:docMkLst>
      <pc:sldChg chg="del">
        <pc:chgData name="Alexandra Le Bras" userId="5153c689-b14b-471b-9cb0-9e9db3b9e899" providerId="ADAL" clId="{46E1D936-2C78-4791-9B2B-5869E6F894A0}" dt="2025-07-11T11:08:35.082" v="0" actId="47"/>
        <pc:sldMkLst>
          <pc:docMk/>
          <pc:sldMk cId="3369541757" sldId="256"/>
        </pc:sldMkLst>
      </pc:sldChg>
      <pc:sldChg chg="del">
        <pc:chgData name="Alexandra Le Bras" userId="5153c689-b14b-471b-9cb0-9e9db3b9e899" providerId="ADAL" clId="{46E1D936-2C78-4791-9B2B-5869E6F894A0}" dt="2025-07-11T11:08:36.273" v="1" actId="47"/>
        <pc:sldMkLst>
          <pc:docMk/>
          <pc:sldMk cId="1824282354" sldId="258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7A7268-56F8-752C-DB1B-107CECEED58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CB2BCA4-3A69-3186-373A-1153C68509A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9CF3FA-0228-3DCC-D4A1-77070DC0E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52759-3AF1-4338-9238-DD7A0F56D48F}" type="datetimeFigureOut">
              <a:rPr lang="en-GB" smtClean="0"/>
              <a:t>11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225CDE-0558-DBAA-483A-48E9DA4D5F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4A5AF5-E7C0-B887-CE2D-3A809A0474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9F68D-D32F-43B1-A381-D6CB7325E5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39772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48B5B2-0BA2-3693-A89C-FB86360867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92EB2C-3DFB-37C8-F751-F4A0BF62D7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2C2E0D-D96A-7905-2A34-34B52A8B3B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52759-3AF1-4338-9238-DD7A0F56D48F}" type="datetimeFigureOut">
              <a:rPr lang="en-GB" smtClean="0"/>
              <a:t>11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CA160C-E64D-055D-E4F3-3C5EA2275C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1E8F1B-0499-DF22-6B52-E5FE919A83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9F68D-D32F-43B1-A381-D6CB7325E5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67858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E39B23-4153-6D9E-2874-A9D7EF4810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5D8E476-3DE8-8EF6-6686-5619E045B2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DE315D-140D-116E-CA12-4A3B78B05B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52759-3AF1-4338-9238-DD7A0F56D48F}" type="datetimeFigureOut">
              <a:rPr lang="en-GB" smtClean="0"/>
              <a:t>11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D25F9A-AD3E-6C24-E857-FC4A807767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618800-91F9-F676-9244-E2784F3BC9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9F68D-D32F-43B1-A381-D6CB7325E5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9248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502459-7A47-4AD7-C4E1-288B398484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C94B86-2225-AE19-17D6-6F70E9D27F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6DD530-F40E-23AF-EBA0-3B854CE61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52759-3AF1-4338-9238-DD7A0F56D48F}" type="datetimeFigureOut">
              <a:rPr lang="en-GB" smtClean="0"/>
              <a:t>11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64DBB8-3F87-6A01-D4BD-21CCD5C447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27E85B-1432-3E84-653D-7B7F14422F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9F68D-D32F-43B1-A381-D6CB7325E5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88763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A4DB7C-98C5-CC93-8429-AC66E2D367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79D34A-BF7C-131C-74C3-FAA94213AF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BB8935-69C5-2F7F-0E9D-4D71261367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52759-3AF1-4338-9238-DD7A0F56D48F}" type="datetimeFigureOut">
              <a:rPr lang="en-GB" smtClean="0"/>
              <a:t>11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04C9B6-3613-6A37-6C42-7E95D6ADE7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434E05-ED9B-B934-8D2E-FF9012AF4E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9F68D-D32F-43B1-A381-D6CB7325E5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42817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77761A-C6F5-E0B3-8149-94D02D2E3B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D7F33E-9D1D-F20C-D7C4-66259D7A862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1F4464-B2FF-08CB-9938-FBE878831D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954290-DBCE-CCE9-1180-57E62176C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52759-3AF1-4338-9238-DD7A0F56D48F}" type="datetimeFigureOut">
              <a:rPr lang="en-GB" smtClean="0"/>
              <a:t>11/07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C9F4A0-4625-4B04-78E8-251E47D865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21B798-505F-1637-B0A8-CC6BAC8F9F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9F68D-D32F-43B1-A381-D6CB7325E5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1887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92076D-73F5-87B0-3D57-7A10494F04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F50E49-BB7D-3EED-6351-3E35572E22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823064-7634-F926-50AC-DB7B06867A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C7AFC5B-0F9D-4D04-50A3-D2CD6F30ADC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6C79212-FB37-7105-56E1-E38C9A55A8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B14047C-8F9D-D80F-C4F3-F57C068F47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52759-3AF1-4338-9238-DD7A0F56D48F}" type="datetimeFigureOut">
              <a:rPr lang="en-GB" smtClean="0"/>
              <a:t>11/07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94E74BD-5A2D-FA61-FFF4-EE1CDC3DA7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A91AE9A-77F9-C6C4-6EEB-37F8170CFE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9F68D-D32F-43B1-A381-D6CB7325E5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943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7CCD0A-A29B-0FD2-944A-B8108E6851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2C32FA2-CA93-F5D3-E0D5-E9B2A88550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52759-3AF1-4338-9238-DD7A0F56D48F}" type="datetimeFigureOut">
              <a:rPr lang="en-GB" smtClean="0"/>
              <a:t>11/07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9127C9B-F044-1B6E-72C6-C1CC16E38C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F4ACEFF-A9C2-1CC3-D421-843F4031D6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9F68D-D32F-43B1-A381-D6CB7325E5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3699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FD886BC-03B5-9717-BCC0-CD4F7340C5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52759-3AF1-4338-9238-DD7A0F56D48F}" type="datetimeFigureOut">
              <a:rPr lang="en-GB" smtClean="0"/>
              <a:t>11/07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B988537-B48D-2CC6-5DB5-A400C469D3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414BFF3-48D8-166E-81AE-CAA5CFD4CE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9F68D-D32F-43B1-A381-D6CB7325E5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01394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619E18-1D28-8B2C-3770-0FAD381DA0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8C4604-251F-2A78-AAC6-4CE78DA27EB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CD3CAAE-2035-2158-8464-6E861BE5AE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455E9F-5D6E-CF36-5578-1968AF29A4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52759-3AF1-4338-9238-DD7A0F56D48F}" type="datetimeFigureOut">
              <a:rPr lang="en-GB" smtClean="0"/>
              <a:t>11/07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5ADA87-D4DD-E16E-2B31-70206F544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00A240-10F3-76F9-A28F-237E1FA7D4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9F68D-D32F-43B1-A381-D6CB7325E5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4777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D0E50F-2F13-34D8-12D6-9659080E34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12AD139-A277-3F25-2B70-5C484F9A20F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221774-01C2-2BD5-D50E-3F867B5CCA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BD77D4-20C7-532F-4669-4EFFC81ED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52759-3AF1-4338-9238-DD7A0F56D48F}" type="datetimeFigureOut">
              <a:rPr lang="en-GB" smtClean="0"/>
              <a:t>11/07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369BE1-356E-8FF0-1E48-3DB8E166FC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E23E0D-B67D-0F37-ED57-A5E295D55E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9F68D-D32F-43B1-A381-D6CB7325E5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8389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D014B42-AE76-3FB2-B355-00AA8031D0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965C53-1F93-F479-D798-965F11C521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10C48C-D850-383F-F948-B826297FAA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2C52759-3AF1-4338-9238-DD7A0F56D48F}" type="datetimeFigureOut">
              <a:rPr lang="en-GB" smtClean="0"/>
              <a:t>11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81086B-6925-0D5D-F174-4A9E4D6EB5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68511B-A939-6D2B-F2F5-EE78AFC652D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989F68D-D32F-43B1-A381-D6CB7325E5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4732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77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A close-up of a black and white photo&#10;&#10;AI-generated content may be incorrect.">
            <a:extLst>
              <a:ext uri="{FF2B5EF4-FFF2-40B4-BE49-F238E27FC236}">
                <a16:creationId xmlns:a16="http://schemas.microsoft.com/office/drawing/2014/main" id="{A5E66F75-9D20-B78C-187C-BB571DFE46F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4008" y="3988368"/>
            <a:ext cx="2067397" cy="2710544"/>
          </a:xfrm>
          <a:prstGeom prst="rect">
            <a:avLst/>
          </a:prstGeom>
        </p:spPr>
      </p:pic>
      <p:pic>
        <p:nvPicPr>
          <p:cNvPr id="15" name="Picture 14" descr="A row of black squares&#10;&#10;AI-generated content may be incorrect.">
            <a:extLst>
              <a:ext uri="{FF2B5EF4-FFF2-40B4-BE49-F238E27FC236}">
                <a16:creationId xmlns:a16="http://schemas.microsoft.com/office/drawing/2014/main" id="{C22DDC05-6A2D-9D17-431E-94AB79A9B11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3494" y="4000416"/>
            <a:ext cx="1982335" cy="2586859"/>
          </a:xfrm>
          <a:prstGeom prst="rect">
            <a:avLst/>
          </a:prstGeom>
        </p:spPr>
      </p:pic>
      <p:pic>
        <p:nvPicPr>
          <p:cNvPr id="17" name="Picture 16" descr="A close-up of a test&#10;&#10;AI-generated content may be incorrect.">
            <a:extLst>
              <a:ext uri="{FF2B5EF4-FFF2-40B4-BE49-F238E27FC236}">
                <a16:creationId xmlns:a16="http://schemas.microsoft.com/office/drawing/2014/main" id="{57C85D88-8884-6035-844F-A74CC1639C8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6524" y="4000416"/>
            <a:ext cx="1982335" cy="2710544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672CDE68-FB48-FF23-39D1-306EEE15153B}"/>
              </a:ext>
            </a:extLst>
          </p:cNvPr>
          <p:cNvSpPr txBox="1"/>
          <p:nvPr/>
        </p:nvSpPr>
        <p:spPr>
          <a:xfrm>
            <a:off x="130629" y="147040"/>
            <a:ext cx="6096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1" i="0" u="none" strike="noStrike" baseline="0" dirty="0">
                <a:solidFill>
                  <a:srgbClr val="000000"/>
                </a:solidFill>
                <a:latin typeface="Aptos" panose="020B0004020202020204" pitchFamily="34" charset="0"/>
              </a:rPr>
              <a:t>Figure 4B </a:t>
            </a:r>
            <a:endParaRPr lang="en-GB" sz="1800" b="0" i="0" u="none" strike="noStrike" baseline="0" dirty="0">
              <a:solidFill>
                <a:srgbClr val="000000"/>
              </a:solidFill>
              <a:latin typeface="Aptos" panose="020B0004020202020204" pitchFamily="34" charset="0"/>
            </a:endParaRPr>
          </a:p>
          <a:p>
            <a:endParaRPr lang="en-GB" sz="1800" b="0" i="0" u="none" strike="noStrike" baseline="0" dirty="0">
              <a:latin typeface="Aptos" panose="020B00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FD32053-6BE1-09A9-AA97-E733CEAD7B91}"/>
              </a:ext>
            </a:extLst>
          </p:cNvPr>
          <p:cNvSpPr txBox="1"/>
          <p:nvPr/>
        </p:nvSpPr>
        <p:spPr>
          <a:xfrm>
            <a:off x="1838642" y="3619036"/>
            <a:ext cx="265788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0" i="0" u="none" strike="noStrike" baseline="0" dirty="0">
                <a:latin typeface="Aptos" panose="020B0004020202020204" pitchFamily="34" charset="0"/>
              </a:rPr>
              <a:t>2x </a:t>
            </a:r>
            <a:r>
              <a:rPr lang="en-GB" sz="1800" b="0" i="0" u="none" strike="noStrike" baseline="0" dirty="0" err="1">
                <a:latin typeface="Aptos" panose="020B0004020202020204" pitchFamily="34" charset="0"/>
              </a:rPr>
              <a:t>MetRS</a:t>
            </a:r>
            <a:r>
              <a:rPr lang="en-GB" sz="1800" b="0" i="0" u="none" strike="noStrike" baseline="0" dirty="0">
                <a:latin typeface="Aptos" panose="020B0004020202020204" pitchFamily="34" charset="0"/>
              </a:rPr>
              <a:t>* 2x Tubulin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E8AE7D2-AB35-B3F9-9CF9-BD5C0449D887}"/>
              </a:ext>
            </a:extLst>
          </p:cNvPr>
          <p:cNvSpPr txBox="1"/>
          <p:nvPr/>
        </p:nvSpPr>
        <p:spPr>
          <a:xfrm>
            <a:off x="4788036" y="3619036"/>
            <a:ext cx="178339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0" i="0" u="none" strike="noStrike" baseline="0" dirty="0">
                <a:latin typeface="Aptos" panose="020B0004020202020204" pitchFamily="34" charset="0"/>
              </a:rPr>
              <a:t>2x </a:t>
            </a:r>
            <a:r>
              <a:rPr lang="en-GB" sz="1800" b="0" i="0" u="none" strike="noStrike" baseline="0" dirty="0" err="1">
                <a:latin typeface="Aptos" panose="020B0004020202020204" pitchFamily="34" charset="0"/>
              </a:rPr>
              <a:t>MetRS</a:t>
            </a:r>
            <a:r>
              <a:rPr lang="en-GB" sz="1800" b="0" i="0" u="none" strike="noStrike" baseline="0" dirty="0">
                <a:latin typeface="Aptos" panose="020B0004020202020204" pitchFamily="34" charset="0"/>
              </a:rPr>
              <a:t>* GFP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7FE7370-BE3A-4188-C857-DF306D5895A5}"/>
              </a:ext>
            </a:extLst>
          </p:cNvPr>
          <p:cNvSpPr txBox="1"/>
          <p:nvPr/>
        </p:nvSpPr>
        <p:spPr>
          <a:xfrm>
            <a:off x="6821898" y="3619036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0" i="0" u="none" strike="noStrike" baseline="0" dirty="0">
                <a:latin typeface="Aptos" panose="020B0004020202020204" pitchFamily="34" charset="0"/>
              </a:rPr>
              <a:t>2x </a:t>
            </a:r>
            <a:r>
              <a:rPr lang="en-GB" sz="1800" b="0" i="0" u="none" strike="noStrike" baseline="0" dirty="0" err="1">
                <a:latin typeface="Aptos" panose="020B0004020202020204" pitchFamily="34" charset="0"/>
              </a:rPr>
              <a:t>MetRS</a:t>
            </a:r>
            <a:r>
              <a:rPr lang="en-GB" sz="1800" b="0" i="0" u="none" strike="noStrike" baseline="0" dirty="0">
                <a:latin typeface="Aptos" panose="020B0004020202020204" pitchFamily="34" charset="0"/>
              </a:rPr>
              <a:t>* Biotin </a:t>
            </a:r>
            <a:endParaRPr lang="en-GB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E5BE860-0478-2F96-E1AD-6D1147DD63C2}"/>
              </a:ext>
            </a:extLst>
          </p:cNvPr>
          <p:cNvSpPr txBox="1"/>
          <p:nvPr/>
        </p:nvSpPr>
        <p:spPr>
          <a:xfrm>
            <a:off x="1840464" y="528420"/>
            <a:ext cx="2016578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en-GB" sz="1200" b="0" i="0" u="none" strike="noStrike" baseline="0" dirty="0">
              <a:latin typeface="Aptos" panose="020B0004020202020204" pitchFamily="34" charset="0"/>
            </a:endParaRPr>
          </a:p>
          <a:p>
            <a:r>
              <a:rPr lang="en-GB" sz="1800" b="0" i="0" u="none" strike="noStrike" baseline="0" dirty="0">
                <a:latin typeface="Aptos" panose="020B0004020202020204" pitchFamily="34" charset="0"/>
              </a:rPr>
              <a:t>3x </a:t>
            </a:r>
            <a:r>
              <a:rPr lang="en-GB" sz="1800" b="0" i="0" u="none" strike="noStrike" baseline="0" dirty="0" err="1">
                <a:latin typeface="Aptos" panose="020B0004020202020204" pitchFamily="34" charset="0"/>
              </a:rPr>
              <a:t>MetRS</a:t>
            </a:r>
            <a:r>
              <a:rPr lang="en-GB" sz="1800" b="0" i="0" u="none" strike="noStrike" baseline="0" dirty="0">
                <a:latin typeface="Aptos" panose="020B0004020202020204" pitchFamily="34" charset="0"/>
              </a:rPr>
              <a:t>* Tubulin 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995796E-B9B2-F7CC-8683-1CAB2024C76A}"/>
              </a:ext>
            </a:extLst>
          </p:cNvPr>
          <p:cNvSpPr txBox="1"/>
          <p:nvPr/>
        </p:nvSpPr>
        <p:spPr>
          <a:xfrm>
            <a:off x="4496524" y="522396"/>
            <a:ext cx="2637064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en-GB" sz="1200" b="0" i="0" u="none" strike="noStrike" baseline="0" dirty="0">
              <a:latin typeface="Aptos" panose="020B0004020202020204" pitchFamily="34" charset="0"/>
            </a:endParaRPr>
          </a:p>
          <a:p>
            <a:r>
              <a:rPr lang="en-GB" sz="1800" b="0" i="0" u="none" strike="noStrike" baseline="0" dirty="0">
                <a:latin typeface="Aptos" panose="020B0004020202020204" pitchFamily="34" charset="0"/>
              </a:rPr>
              <a:t>3x </a:t>
            </a:r>
            <a:r>
              <a:rPr lang="en-GB" sz="1800" b="0" i="0" u="none" strike="noStrike" baseline="0" dirty="0" err="1">
                <a:latin typeface="Aptos" panose="020B0004020202020204" pitchFamily="34" charset="0"/>
              </a:rPr>
              <a:t>MetRS</a:t>
            </a:r>
            <a:r>
              <a:rPr lang="en-GB" sz="1800" b="0" i="0" u="none" strike="noStrike" baseline="0" dirty="0">
                <a:latin typeface="Aptos" panose="020B0004020202020204" pitchFamily="34" charset="0"/>
              </a:rPr>
              <a:t>* GFP </a:t>
            </a:r>
          </a:p>
          <a:p>
            <a:endParaRPr lang="en-GB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25770ED-B5B7-8AED-5BFA-646F9547ADC8}"/>
              </a:ext>
            </a:extLst>
          </p:cNvPr>
          <p:cNvSpPr txBox="1"/>
          <p:nvPr/>
        </p:nvSpPr>
        <p:spPr>
          <a:xfrm>
            <a:off x="6866111" y="470205"/>
            <a:ext cx="6460670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en-GB" sz="1200" b="0" i="0" u="none" strike="noStrike" baseline="0" dirty="0">
              <a:latin typeface="Aptos" panose="020B0004020202020204" pitchFamily="34" charset="0"/>
            </a:endParaRPr>
          </a:p>
          <a:p>
            <a:r>
              <a:rPr lang="en-GB" sz="1800" b="0" i="0" u="none" strike="noStrike" baseline="0" dirty="0">
                <a:latin typeface="Aptos" panose="020B0004020202020204" pitchFamily="34" charset="0"/>
              </a:rPr>
              <a:t>3x </a:t>
            </a:r>
            <a:r>
              <a:rPr lang="en-GB" sz="1800" b="0" i="0" u="none" strike="noStrike" baseline="0" dirty="0" err="1">
                <a:latin typeface="Aptos" panose="020B0004020202020204" pitchFamily="34" charset="0"/>
              </a:rPr>
              <a:t>MetRS</a:t>
            </a:r>
            <a:r>
              <a:rPr lang="en-GB" sz="1800" b="0" i="0" u="none" strike="noStrike" baseline="0" dirty="0">
                <a:latin typeface="Aptos" panose="020B0004020202020204" pitchFamily="34" charset="0"/>
              </a:rPr>
              <a:t>* Biotin</a:t>
            </a:r>
            <a:endParaRPr lang="en-GB" dirty="0"/>
          </a:p>
        </p:txBody>
      </p:sp>
      <p:pic>
        <p:nvPicPr>
          <p:cNvPr id="36" name="Picture 35" descr="A close-up of a white sheet&#10;&#10;AI-generated content may be incorrect.">
            <a:extLst>
              <a:ext uri="{FF2B5EF4-FFF2-40B4-BE49-F238E27FC236}">
                <a16:creationId xmlns:a16="http://schemas.microsoft.com/office/drawing/2014/main" id="{4276FAE1-3E81-7419-EA1B-8A98F9A81D6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30" r="-12430"/>
          <a:stretch>
            <a:fillRect/>
          </a:stretch>
        </p:blipFill>
        <p:spPr>
          <a:xfrm>
            <a:off x="6821898" y="1034901"/>
            <a:ext cx="2449889" cy="2449889"/>
          </a:xfrm>
          <a:prstGeom prst="rect">
            <a:avLst/>
          </a:prstGeom>
        </p:spPr>
      </p:pic>
      <p:pic>
        <p:nvPicPr>
          <p:cNvPr id="38" name="Picture 37" descr="A close-up of a green light&#10;&#10;AI-generated content may be incorrect.">
            <a:extLst>
              <a:ext uri="{FF2B5EF4-FFF2-40B4-BE49-F238E27FC236}">
                <a16:creationId xmlns:a16="http://schemas.microsoft.com/office/drawing/2014/main" id="{EE202A07-87B6-DF17-FC1E-E9DE11C8FD2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678082" y="1188587"/>
            <a:ext cx="1416441" cy="2121120"/>
          </a:xfrm>
          <a:prstGeom prst="rect">
            <a:avLst/>
          </a:prstGeom>
        </p:spPr>
      </p:pic>
      <p:pic>
        <p:nvPicPr>
          <p:cNvPr id="40" name="Picture 39" descr="A close-up of a test&#10;&#10;AI-generated content may be incorrect.">
            <a:extLst>
              <a:ext uri="{FF2B5EF4-FFF2-40B4-BE49-F238E27FC236}">
                <a16:creationId xmlns:a16="http://schemas.microsoft.com/office/drawing/2014/main" id="{C6B60836-C7DD-F442-6325-E62A72FFD99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4336" y="1195832"/>
            <a:ext cx="2536371" cy="23097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95579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ef01f8a6-db39-445d-ae4f-e1aa8d09bd5b">
      <Terms xmlns="http://schemas.microsoft.com/office/infopath/2007/PartnerControls"/>
    </lcf76f155ced4ddcb4097134ff3c332f>
    <TaxCatchAll xmlns="721675c7-1686-4024-8eae-ebecabfc1ee5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F04F6099F0E5E4585273245C3F67440" ma:contentTypeVersion="13" ma:contentTypeDescription="Create a new document." ma:contentTypeScope="" ma:versionID="a271034dd1d0512ad8da02ac59518da0">
  <xsd:schema xmlns:xsd="http://www.w3.org/2001/XMLSchema" xmlns:xs="http://www.w3.org/2001/XMLSchema" xmlns:p="http://schemas.microsoft.com/office/2006/metadata/properties" xmlns:ns2="ef01f8a6-db39-445d-ae4f-e1aa8d09bd5b" xmlns:ns3="721675c7-1686-4024-8eae-ebecabfc1ee5" targetNamespace="http://schemas.microsoft.com/office/2006/metadata/properties" ma:root="true" ma:fieldsID="8a27b981a7d35ad09306791a5cd976f4" ns2:_="" ns3:_="">
    <xsd:import namespace="ef01f8a6-db39-445d-ae4f-e1aa8d09bd5b"/>
    <xsd:import namespace="721675c7-1686-4024-8eae-ebecabfc1ee5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LengthInSeconds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f01f8a6-db39-445d-ae4f-e1aa8d09bd5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3" nillable="true" ma:taxonomy="true" ma:internalName="lcf76f155ced4ddcb4097134ff3c332f" ma:taxonomyFieldName="MediaServiceImageTags" ma:displayName="Image Tags" ma:readOnly="false" ma:fieldId="{5cf76f15-5ced-4ddc-b409-7134ff3c332f}" ma:taxonomyMulti="true" ma:sspId="4fb58666-e629-4e5a-b780-b8dcc15b318b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5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20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21675c7-1686-4024-8eae-ebecabfc1ee5" elementFormDefault="qualified">
    <xsd:import namespace="http://schemas.microsoft.com/office/2006/documentManagement/types"/>
    <xsd:import namespace="http://schemas.microsoft.com/office/infopath/2007/PartnerControls"/>
    <xsd:element name="TaxCatchAll" ma:index="14" nillable="true" ma:displayName="Taxonomy Catch All Column" ma:hidden="true" ma:list="{cf1ae864-1b6b-479c-a82c-54333512abef}" ma:internalName="TaxCatchAll" ma:showField="CatchAllData" ma:web="721675c7-1686-4024-8eae-ebecabfc1ee5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9C543347-2E96-4429-A7C0-18F736C0DB4A}">
  <ds:schemaRefs>
    <ds:schemaRef ds:uri="http://schemas.microsoft.com/office/2006/metadata/properties"/>
    <ds:schemaRef ds:uri="http://schemas.microsoft.com/office/infopath/2007/PartnerControls"/>
    <ds:schemaRef ds:uri="ef01f8a6-db39-445d-ae4f-e1aa8d09bd5b"/>
    <ds:schemaRef ds:uri="721675c7-1686-4024-8eae-ebecabfc1ee5"/>
  </ds:schemaRefs>
</ds:datastoreItem>
</file>

<file path=customXml/itemProps2.xml><?xml version="1.0" encoding="utf-8"?>
<ds:datastoreItem xmlns:ds="http://schemas.openxmlformats.org/officeDocument/2006/customXml" ds:itemID="{0C7F8F55-7133-4E13-A836-A5E2DDE685B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4FB2282D-CEA4-4F8D-A633-286979B2B09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f01f8a6-db39-445d-ae4f-e1aa8d09bd5b"/>
    <ds:schemaRef ds:uri="721675c7-1686-4024-8eae-ebecabfc1ee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27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lexandra Le Bras</dc:creator>
  <cp:lastModifiedBy>Alexandra Le Bras</cp:lastModifiedBy>
  <cp:revision>1</cp:revision>
  <dcterms:created xsi:type="dcterms:W3CDTF">2025-07-11T10:40:21Z</dcterms:created>
  <dcterms:modified xsi:type="dcterms:W3CDTF">2025-07-11T11:08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F04F6099F0E5E4585273245C3F67440</vt:lpwstr>
  </property>
  <property fmtid="{D5CDD505-2E9C-101B-9397-08002B2CF9AE}" pid="3" name="MediaServiceImageTags">
    <vt:lpwstr/>
  </property>
</Properties>
</file>